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2" userDrawn="1">
          <p15:clr>
            <a:srgbClr val="A4A3A4"/>
          </p15:clr>
        </p15:guide>
        <p15:guide id="2" pos="3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96"/>
      </p:cViewPr>
      <p:guideLst>
        <p:guide orient="horz" pos="822"/>
        <p:guide pos="3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80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373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059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463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1639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71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4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86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948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132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1146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61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714703" y="136634"/>
            <a:ext cx="341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6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그룹 29"/>
          <p:cNvGrpSpPr/>
          <p:nvPr/>
        </p:nvGrpSpPr>
        <p:grpSpPr>
          <a:xfrm>
            <a:off x="399688" y="888627"/>
            <a:ext cx="11053752" cy="3993392"/>
            <a:chOff x="399688" y="888627"/>
            <a:chExt cx="11053752" cy="3993392"/>
          </a:xfrm>
        </p:grpSpPr>
        <p:pic>
          <p:nvPicPr>
            <p:cNvPr id="31" name="그림 3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60388" y="888627"/>
              <a:ext cx="5372100" cy="3467100"/>
            </a:xfrm>
            <a:prstGeom prst="rect">
              <a:avLst/>
            </a:prstGeom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21730" y="888627"/>
              <a:ext cx="5231710" cy="3467100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625545" y="4285981"/>
              <a:ext cx="10827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eason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 S   F  W  Sp S   F  W  Sp S   F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S   F  W  Sp S   F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56368" y="4574242"/>
              <a:ext cx="10797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  Year           2005                 2006                 2007                2008                2009             2010            2011             2012            2013                   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직선 연결선 34"/>
            <p:cNvCxnSpPr/>
            <p:nvPr/>
          </p:nvCxnSpPr>
          <p:spPr>
            <a:xfrm>
              <a:off x="1476175" y="4595262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>
              <a:off x="2669099" y="4595262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연결선 36"/>
            <p:cNvCxnSpPr/>
            <p:nvPr/>
          </p:nvCxnSpPr>
          <p:spPr>
            <a:xfrm>
              <a:off x="3897155" y="4595262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직선 연결선 37"/>
            <p:cNvCxnSpPr/>
            <p:nvPr/>
          </p:nvCxnSpPr>
          <p:spPr>
            <a:xfrm>
              <a:off x="5090079" y="4595262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직선 연결선 38"/>
            <p:cNvCxnSpPr/>
            <p:nvPr/>
          </p:nvCxnSpPr>
          <p:spPr>
            <a:xfrm>
              <a:off x="6323626" y="4595262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직선 연결선 39"/>
            <p:cNvCxnSpPr/>
            <p:nvPr/>
          </p:nvCxnSpPr>
          <p:spPr>
            <a:xfrm>
              <a:off x="7357241" y="4596293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/>
            <p:cNvCxnSpPr/>
            <p:nvPr/>
          </p:nvCxnSpPr>
          <p:spPr>
            <a:xfrm>
              <a:off x="8370914" y="4597323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직선 연결선 41"/>
            <p:cNvCxnSpPr/>
            <p:nvPr/>
          </p:nvCxnSpPr>
          <p:spPr>
            <a:xfrm>
              <a:off x="9383508" y="4595262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직선 연결선 42"/>
            <p:cNvCxnSpPr/>
            <p:nvPr/>
          </p:nvCxnSpPr>
          <p:spPr>
            <a:xfrm>
              <a:off x="10406376" y="4595262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 rot="16200000">
              <a:off x="-153517" y="2505292"/>
              <a:ext cx="14449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PM</a:t>
              </a:r>
              <a:r>
                <a:rPr lang="en-US" altLang="ko-KR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, µg/m</a:t>
              </a:r>
              <a:r>
                <a:rPr lang="en-US" altLang="ko-KR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05553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</TotalTime>
  <Words>56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oGES</dc:creator>
  <cp:lastModifiedBy>이제인</cp:lastModifiedBy>
  <cp:revision>48</cp:revision>
  <dcterms:created xsi:type="dcterms:W3CDTF">2021-12-14T01:01:23Z</dcterms:created>
  <dcterms:modified xsi:type="dcterms:W3CDTF">2022-12-16T00:55:44Z</dcterms:modified>
</cp:coreProperties>
</file>